
<file path=[Content_Types].xml><?xml version="1.0" encoding="utf-8"?>
<Types xmlns="http://schemas.openxmlformats.org/package/2006/content-types">
  <Default Extension="bin" ContentType="application/vnd.openxmlformats-officedocument.presentationml.printerSettings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120" y="-33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printerSettings" Target="printerSettings/printerSettings1.bin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erit\Documents\manuscripts\liz%20rnaseq\data\sept%202015%20revision\sup%20fig%20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92022918851987"/>
          <c:y val="0.043558963098697"/>
          <c:w val="0.898921743439007"/>
          <c:h val="0.868063793303487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Sheet1!$O$3</c:f>
              <c:strCache>
                <c:ptCount val="1"/>
                <c:pt idx="0">
                  <c:v>senescent human astrocytes</c:v>
                </c:pt>
              </c:strCache>
            </c:strRef>
          </c:tx>
          <c:spPr>
            <a:solidFill>
              <a:srgbClr val="C00000"/>
            </a:solidFill>
          </c:spPr>
          <c:invertIfNegative val="0"/>
          <c:cat>
            <c:strRef>
              <c:f>Sheet1!$P$4:$S$4</c:f>
              <c:strCache>
                <c:ptCount val="4"/>
                <c:pt idx="0">
                  <c:v>HLA-DQA1</c:v>
                </c:pt>
                <c:pt idx="1">
                  <c:v>HLA-DRB5</c:v>
                </c:pt>
                <c:pt idx="2">
                  <c:v>HLA-DRA</c:v>
                </c:pt>
                <c:pt idx="3">
                  <c:v>CD74</c:v>
                </c:pt>
              </c:strCache>
            </c:strRef>
          </c:cat>
          <c:val>
            <c:numRef>
              <c:f>Sheet1!$P$3:$S$3</c:f>
              <c:numCache>
                <c:formatCode>General</c:formatCode>
                <c:ptCount val="4"/>
                <c:pt idx="0">
                  <c:v>0.0709867482146351</c:v>
                </c:pt>
                <c:pt idx="1">
                  <c:v>0.0779436048583513</c:v>
                </c:pt>
                <c:pt idx="2">
                  <c:v>0.0637290299703748</c:v>
                </c:pt>
                <c:pt idx="3">
                  <c:v>0.149764670334757</c:v>
                </c:pt>
              </c:numCache>
            </c:numRef>
          </c:val>
        </c:ser>
        <c:ser>
          <c:idx val="0"/>
          <c:order val="1"/>
          <c:tx>
            <c:strRef>
              <c:f>Sheet1!$O$2</c:f>
              <c:strCache>
                <c:ptCount val="1"/>
                <c:pt idx="0">
                  <c:v>aged rat brai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Sheet1!$P$4:$S$4</c:f>
              <c:strCache>
                <c:ptCount val="4"/>
                <c:pt idx="0">
                  <c:v>HLA-DQA1</c:v>
                </c:pt>
                <c:pt idx="1">
                  <c:v>HLA-DRB5</c:v>
                </c:pt>
                <c:pt idx="2">
                  <c:v>HLA-DRA</c:v>
                </c:pt>
                <c:pt idx="3">
                  <c:v>CD74</c:v>
                </c:pt>
              </c:strCache>
            </c:strRef>
          </c:cat>
          <c:val>
            <c:numRef>
              <c:f>Sheet1!$P$2:$S$2</c:f>
              <c:numCache>
                <c:formatCode>General</c:formatCode>
                <c:ptCount val="4"/>
                <c:pt idx="0">
                  <c:v>0.28322097132395</c:v>
                </c:pt>
                <c:pt idx="1">
                  <c:v>0.22687978882929</c:v>
                </c:pt>
                <c:pt idx="2">
                  <c:v>0.275476278969153</c:v>
                </c:pt>
                <c:pt idx="3">
                  <c:v>0.30992692498474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95645784"/>
        <c:axId val="279694184"/>
      </c:barChart>
      <c:catAx>
        <c:axId val="29564578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279694184"/>
        <c:crosses val="autoZero"/>
        <c:auto val="1"/>
        <c:lblAlgn val="ctr"/>
        <c:lblOffset val="100"/>
        <c:noMultiLvlLbl val="0"/>
      </c:catAx>
      <c:valAx>
        <c:axId val="279694184"/>
        <c:scaling>
          <c:orientation val="minMax"/>
          <c:max val="0.3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/>
                  <a:t>expression</a:t>
                </a:r>
                <a:r>
                  <a:rPr lang="en-US" sz="1200" baseline="0"/>
                  <a:t> (fraction of control)</a:t>
                </a:r>
                <a:endParaRPr lang="en-US" sz="1200"/>
              </a:p>
            </c:rich>
          </c:tx>
          <c:layout>
            <c:manualLayout>
              <c:xMode val="edge"/>
              <c:yMode val="edge"/>
              <c:x val="0.00620267667733191"/>
              <c:y val="0.26862871070258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29564578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403523435661845"/>
          <c:y val="0.0209913759467073"/>
          <c:w val="0.240449080691821"/>
          <c:h val="0.107514739174722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B10A-1E22-461A-84B1-5FD83A6337FA}" type="datetimeFigureOut">
              <a:rPr lang="en-US" smtClean="0"/>
              <a:t>8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374DA-DA39-4E08-8D4B-38D49C6F0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568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B10A-1E22-461A-84B1-5FD83A6337FA}" type="datetimeFigureOut">
              <a:rPr lang="en-US" smtClean="0"/>
              <a:t>8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374DA-DA39-4E08-8D4B-38D49C6F0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659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B10A-1E22-461A-84B1-5FD83A6337FA}" type="datetimeFigureOut">
              <a:rPr lang="en-US" smtClean="0"/>
              <a:t>8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374DA-DA39-4E08-8D4B-38D49C6F0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0017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B10A-1E22-461A-84B1-5FD83A6337FA}" type="datetimeFigureOut">
              <a:rPr lang="en-US" smtClean="0"/>
              <a:t>8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374DA-DA39-4E08-8D4B-38D49C6F0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09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B10A-1E22-461A-84B1-5FD83A6337FA}" type="datetimeFigureOut">
              <a:rPr lang="en-US" smtClean="0"/>
              <a:t>8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374DA-DA39-4E08-8D4B-38D49C6F0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1758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B10A-1E22-461A-84B1-5FD83A6337FA}" type="datetimeFigureOut">
              <a:rPr lang="en-US" smtClean="0"/>
              <a:t>8/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374DA-DA39-4E08-8D4B-38D49C6F0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2277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B10A-1E22-461A-84B1-5FD83A6337FA}" type="datetimeFigureOut">
              <a:rPr lang="en-US" smtClean="0"/>
              <a:t>8/5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374DA-DA39-4E08-8D4B-38D49C6F0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030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B10A-1E22-461A-84B1-5FD83A6337FA}" type="datetimeFigureOut">
              <a:rPr lang="en-US" smtClean="0"/>
              <a:t>8/5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374DA-DA39-4E08-8D4B-38D49C6F0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8726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B10A-1E22-461A-84B1-5FD83A6337FA}" type="datetimeFigureOut">
              <a:rPr lang="en-US" smtClean="0"/>
              <a:t>8/5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374DA-DA39-4E08-8D4B-38D49C6F0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64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B10A-1E22-461A-84B1-5FD83A6337FA}" type="datetimeFigureOut">
              <a:rPr lang="en-US" smtClean="0"/>
              <a:t>8/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374DA-DA39-4E08-8D4B-38D49C6F0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235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B10A-1E22-461A-84B1-5FD83A6337FA}" type="datetimeFigureOut">
              <a:rPr lang="en-US" smtClean="0"/>
              <a:t>8/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374DA-DA39-4E08-8D4B-38D49C6F0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960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E6B10A-1E22-461A-84B1-5FD83A6337FA}" type="datetimeFigureOut">
              <a:rPr lang="en-US" smtClean="0"/>
              <a:t>8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A374DA-DA39-4E08-8D4B-38D49C6F0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94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489559"/>
              </p:ext>
            </p:extLst>
          </p:nvPr>
        </p:nvGraphicFramePr>
        <p:xfrm>
          <a:off x="228600" y="15815"/>
          <a:ext cx="8347364" cy="48438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/>
          <p:cNvSpPr/>
          <p:nvPr/>
        </p:nvSpPr>
        <p:spPr>
          <a:xfrm>
            <a:off x="228600" y="5029200"/>
            <a:ext cx="86106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d changes in MHC Class II-related genes in aging rat brain and human astrocyte senescence. Black: MHC Class II genes that were changing significantly between 12 month and 28 month rat brain from Wood et al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13. R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fold changes in human homologues of these genes in human astrocyte senescence. Rat homologues are, for HLA-DQA1: RT1-ba, for HLA-DRB5: RT1-Db1, for HLA-DRA: RT1-Da, for CD74: CD74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isoform for the human homologue of RT1-Bb, which was another gene downregulated in rat, was detected in human astrocyte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values are shown as fraction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controls (pre-senescen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trocytes or 12-month old rat brain)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1574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D4B5B85777C1B42AA7B2E00829C049E" ma:contentTypeVersion="7" ma:contentTypeDescription="Create a new document." ma:contentTypeScope="" ma:versionID="95e1889000582fa1ea767959ed6c08ca">
  <xsd:schema xmlns:xsd="http://www.w3.org/2001/XMLSchema" xmlns:p="http://schemas.microsoft.com/office/2006/metadata/properties" xmlns:ns2="64f0ecf7-d19c-4b88-abc0-1645d5999ad2" targetNamespace="http://schemas.microsoft.com/office/2006/metadata/properties" ma:root="true" ma:fieldsID="1970cc853a1240edc583d79f32ace129" ns2:_="">
    <xsd:import namespace="64f0ecf7-d19c-4b88-abc0-1645d5999ad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64f0ecf7-d19c-4b88-abc0-1645d5999ad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64f0ecf7-d19c-4b88-abc0-1645d5999ad2">Presentation 2.PPTX</DocumentId>
    <IsDeleted xmlns="64f0ecf7-d19c-4b88-abc0-1645d5999ad2">false</IsDeleted>
    <StageName xmlns="64f0ecf7-d19c-4b88-abc0-1645d5999ad2" xsi:nil="true"/>
    <TitleName xmlns="64f0ecf7-d19c-4b88-abc0-1645d5999ad2">Presentation 2.PPTX</TitleName>
    <DocumentType xmlns="64f0ecf7-d19c-4b88-abc0-1645d5999ad2">Presentation</DocumentType>
    <FileFormat xmlns="64f0ecf7-d19c-4b88-abc0-1645d5999ad2">PPTX</FileFormat>
    <Checked_x0020_Out_x0020_To xmlns="64f0ecf7-d19c-4b88-abc0-1645d5999ad2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1A074277-022F-4E8E-B258-0F381592D79D}"/>
</file>

<file path=customXml/itemProps2.xml><?xml version="1.0" encoding="utf-8"?>
<ds:datastoreItem xmlns:ds="http://schemas.openxmlformats.org/officeDocument/2006/customXml" ds:itemID="{8CD018B0-452C-4182-B8BA-F761A9486E4D}"/>
</file>

<file path=customXml/itemProps3.xml><?xml version="1.0" encoding="utf-8"?>
<ds:datastoreItem xmlns:ds="http://schemas.openxmlformats.org/officeDocument/2006/customXml" ds:itemID="{65CA3969-1771-4D8C-AE82-C09FB05EFAD8}"/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151</Words>
  <Application>Microsoft Macintosh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rexel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rit Tüzer</dc:creator>
  <cp:lastModifiedBy>Claudio  Torres</cp:lastModifiedBy>
  <cp:revision>12</cp:revision>
  <dcterms:created xsi:type="dcterms:W3CDTF">2015-09-29T03:09:16Z</dcterms:created>
  <dcterms:modified xsi:type="dcterms:W3CDTF">2016-08-05T14:02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D4B5B85777C1B42AA7B2E00829C049E</vt:lpwstr>
  </property>
</Properties>
</file>